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44" r:id="rId1"/>
  </p:sldMasterIdLst>
  <p:notesMasterIdLst>
    <p:notesMasterId r:id="rId3"/>
  </p:notes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56"/>
    <p:restoredTop sz="94704"/>
  </p:normalViewPr>
  <p:slideViewPr>
    <p:cSldViewPr snapToGrid="0">
      <p:cViewPr varScale="1">
        <p:scale>
          <a:sx n="105" d="100"/>
          <a:sy n="105" d="100"/>
        </p:scale>
        <p:origin x="6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9FE9E2-0560-724C-9551-37C809B279E2}" type="datetimeFigureOut">
              <a:rPr lang="en-GB" smtClean="0"/>
              <a:t>21/07/2025</a:t>
            </a:fld>
            <a:endParaRPr lang="en-GB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408C4E-427F-B44C-8D6A-27366CAA42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65625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7C84C91-CFFB-39D8-9790-7AF953C4065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138F635C-45B7-8024-7A89-B6A4A89D02D6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60F2CA52-6318-9FD9-FDC9-01A390E41319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E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3E3808B-BB80-855F-1680-BD1C27210CA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6FAA090-FA4A-CE41-B174-598650FF9381}" type="slidenum">
              <a:rPr lang="en-SE" smtClean="0"/>
              <a:t>1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3641238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F0D8-2060-D94C-A6CE-0D3B5F1C34A7}" type="datetimeFigureOut">
              <a:rPr lang="en-GB" smtClean="0"/>
              <a:t>21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29768-DB8B-0D4B-B95B-321693363B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0430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F0D8-2060-D94C-A6CE-0D3B5F1C34A7}" type="datetimeFigureOut">
              <a:rPr lang="en-GB" smtClean="0"/>
              <a:t>21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29768-DB8B-0D4B-B95B-321693363B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6397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F0D8-2060-D94C-A6CE-0D3B5F1C34A7}" type="datetimeFigureOut">
              <a:rPr lang="en-GB" smtClean="0"/>
              <a:t>21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29768-DB8B-0D4B-B95B-321693363B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3677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F0D8-2060-D94C-A6CE-0D3B5F1C34A7}" type="datetimeFigureOut">
              <a:rPr lang="en-GB" smtClean="0"/>
              <a:t>21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29768-DB8B-0D4B-B95B-321693363B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5216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F0D8-2060-D94C-A6CE-0D3B5F1C34A7}" type="datetimeFigureOut">
              <a:rPr lang="en-GB" smtClean="0"/>
              <a:t>21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29768-DB8B-0D4B-B95B-321693363B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29098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F0D8-2060-D94C-A6CE-0D3B5F1C34A7}" type="datetimeFigureOut">
              <a:rPr lang="en-GB" smtClean="0"/>
              <a:t>21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29768-DB8B-0D4B-B95B-321693363B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9310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F0D8-2060-D94C-A6CE-0D3B5F1C34A7}" type="datetimeFigureOut">
              <a:rPr lang="en-GB" smtClean="0"/>
              <a:t>21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29768-DB8B-0D4B-B95B-321693363B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91045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F0D8-2060-D94C-A6CE-0D3B5F1C34A7}" type="datetimeFigureOut">
              <a:rPr lang="en-GB" smtClean="0"/>
              <a:t>21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29768-DB8B-0D4B-B95B-321693363B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2831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F0D8-2060-D94C-A6CE-0D3B5F1C34A7}" type="datetimeFigureOut">
              <a:rPr lang="en-GB" smtClean="0"/>
              <a:t>21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29768-DB8B-0D4B-B95B-321693363B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57394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F0D8-2060-D94C-A6CE-0D3B5F1C34A7}" type="datetimeFigureOut">
              <a:rPr lang="en-GB" smtClean="0"/>
              <a:t>21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29768-DB8B-0D4B-B95B-321693363B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4961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sv-SE"/>
              <a:t>Klicka på ikonen för att lägga till en bil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F0D8-2060-D94C-A6CE-0D3B5F1C34A7}" type="datetimeFigureOut">
              <a:rPr lang="en-GB" smtClean="0"/>
              <a:t>21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29768-DB8B-0D4B-B95B-321693363B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68467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5EEF0D8-2060-D94C-A6CE-0D3B5F1C34A7}" type="datetimeFigureOut">
              <a:rPr lang="en-GB" smtClean="0"/>
              <a:t>21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9B29768-DB8B-0D4B-B95B-321693363B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00294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>
          <a:extLst>
            <a:ext uri="{FF2B5EF4-FFF2-40B4-BE49-F238E27FC236}">
              <a16:creationId xmlns:a16="http://schemas.microsoft.com/office/drawing/2014/main" id="{2944E0DE-75B4-6F06-1DCA-2EAB8E8A849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ubrik 3">
            <a:extLst>
              <a:ext uri="{FF2B5EF4-FFF2-40B4-BE49-F238E27FC236}">
                <a16:creationId xmlns:a16="http://schemas.microsoft.com/office/drawing/2014/main" id="{28352623-1647-0856-1DC2-C48D9CC819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90500"/>
            <a:ext cx="10515600" cy="1187851"/>
          </a:xfrm>
        </p:spPr>
        <p:txBody>
          <a:bodyPr anchor="t">
            <a:normAutofit fontScale="90000"/>
          </a:bodyPr>
          <a:lstStyle/>
          <a:p>
            <a:pPr algn="ctr"/>
            <a:r>
              <a:rPr lang="en-US" sz="3200" b="1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e CABI score for Cardiac Arrest Brain </a:t>
            </a:r>
            <a:r>
              <a:rPr lang="en-US" sz="3200" b="1" kern="10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schemia improves </a:t>
            </a:r>
            <a:r>
              <a:rPr lang="en-US" sz="3200" b="1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unctional outcome prediction after cardiac arrest</a:t>
            </a:r>
            <a:endParaRPr lang="sv-SE" sz="6600" dirty="0">
              <a:solidFill>
                <a:schemeClr val="bg1"/>
              </a:solidFill>
            </a:endParaRPr>
          </a:p>
        </p:txBody>
      </p:sp>
      <p:sp>
        <p:nvSpPr>
          <p:cNvPr id="8" name="Rektangel med rundade hörn 7">
            <a:extLst>
              <a:ext uri="{FF2B5EF4-FFF2-40B4-BE49-F238E27FC236}">
                <a16:creationId xmlns:a16="http://schemas.microsoft.com/office/drawing/2014/main" id="{9DE64933-D12D-4B00-078F-7F186E13A01A}"/>
              </a:ext>
            </a:extLst>
          </p:cNvPr>
          <p:cNvSpPr/>
          <p:nvPr/>
        </p:nvSpPr>
        <p:spPr>
          <a:xfrm>
            <a:off x="7334250" y="4118371"/>
            <a:ext cx="4352249" cy="2629691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GB" sz="24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Key message: </a:t>
            </a:r>
          </a:p>
          <a:p>
            <a:r>
              <a:rPr lang="en-GB" sz="24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ABI score may increase the prognostic </a:t>
            </a:r>
            <a:r>
              <a:rPr lang="en-GB" sz="2400" dirty="0">
                <a:solidFill>
                  <a:srgbClr val="000000"/>
                </a:solidFill>
                <a:latin typeface="Times New Roman" panose="02020603050405020304" pitchFamily="18" charset="0"/>
              </a:rPr>
              <a:t>accuracy after cardiac arrest compared to non-standardized MRI assessment</a:t>
            </a:r>
            <a:r>
              <a:rPr lang="en-GB" sz="24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</a:t>
            </a:r>
            <a:endParaRPr lang="en-GB" sz="2400" dirty="0"/>
          </a:p>
        </p:txBody>
      </p:sp>
      <p:sp>
        <p:nvSpPr>
          <p:cNvPr id="9" name="Rektangel med rundade hörn 8">
            <a:extLst>
              <a:ext uri="{FF2B5EF4-FFF2-40B4-BE49-F238E27FC236}">
                <a16:creationId xmlns:a16="http://schemas.microsoft.com/office/drawing/2014/main" id="{D056172E-6AA4-BA35-56FB-9893D3BEE468}"/>
              </a:ext>
            </a:extLst>
          </p:cNvPr>
          <p:cNvSpPr/>
          <p:nvPr/>
        </p:nvSpPr>
        <p:spPr>
          <a:xfrm>
            <a:off x="7720304" y="1143596"/>
            <a:ext cx="3966196" cy="2974777"/>
          </a:xfrm>
          <a:prstGeom prst="roundRect">
            <a:avLst/>
          </a:prstGeom>
          <a:solidFill>
            <a:schemeClr val="accent5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2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hods:</a:t>
            </a:r>
          </a:p>
          <a:p>
            <a:pPr marL="285750" indent="-285750">
              <a:buFontTx/>
              <a:buChar char="-"/>
            </a:pPr>
            <a:r>
              <a:rPr lang="en-GB" sz="2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BI score (0-36p) vs qualitative assessment according to guidelines</a:t>
            </a:r>
          </a:p>
          <a:p>
            <a:pPr marL="285750" indent="-285750">
              <a:buFontTx/>
              <a:buChar char="-"/>
            </a:pPr>
            <a:r>
              <a:rPr lang="en-GB" sz="2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ur radiologists, blinded</a:t>
            </a:r>
          </a:p>
          <a:p>
            <a:pPr marL="285750" indent="-285750">
              <a:buFontTx/>
              <a:buChar char="-"/>
            </a:pPr>
            <a:r>
              <a:rPr lang="en-GB" sz="2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0 patients with accessible brain MRI</a:t>
            </a:r>
          </a:p>
        </p:txBody>
      </p:sp>
      <p:sp>
        <p:nvSpPr>
          <p:cNvPr id="10" name="Rektangel med rundade hörn 9">
            <a:extLst>
              <a:ext uri="{FF2B5EF4-FFF2-40B4-BE49-F238E27FC236}">
                <a16:creationId xmlns:a16="http://schemas.microsoft.com/office/drawing/2014/main" id="{F2582120-03D0-A8DB-265D-AD6A71D2BA59}"/>
              </a:ext>
            </a:extLst>
          </p:cNvPr>
          <p:cNvSpPr/>
          <p:nvPr/>
        </p:nvSpPr>
        <p:spPr>
          <a:xfrm>
            <a:off x="505500" y="4147810"/>
            <a:ext cx="6828750" cy="2600251"/>
          </a:xfrm>
          <a:prstGeom prst="roundRect">
            <a:avLst/>
          </a:prstGeom>
          <a:solidFill>
            <a:schemeClr val="accent5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GB" sz="2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BI score: </a:t>
            </a:r>
            <a:br>
              <a:rPr lang="en-GB" sz="28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2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 AUC: 0.87-0.92</a:t>
            </a:r>
            <a:r>
              <a:rPr lang="sv-SE" sz="2400" dirty="0"/>
              <a:t> </a:t>
            </a:r>
            <a:r>
              <a:rPr lang="sv-SE" sz="2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p &lt; 0.05 vs. Routine assessment)</a:t>
            </a:r>
            <a:endParaRPr lang="en-GB" sz="2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2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 S</a:t>
            </a:r>
            <a:r>
              <a:rPr lang="en-GB" sz="24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cificity 76.9–100%, Sensitivity 59.7-85.7% (c</a:t>
            </a:r>
            <a:r>
              <a:rPr lang="en-GB" sz="2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t-off </a:t>
            </a:r>
            <a:r>
              <a:rPr lang="en-GB" sz="2400" dirty="0">
                <a:solidFill>
                  <a:schemeClr val="tx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itchFamily="2" charset="2"/>
              </a:rPr>
              <a:t>8</a:t>
            </a:r>
            <a:r>
              <a:rPr lang="en-GB" sz="2400" dirty="0">
                <a:solidFill>
                  <a:schemeClr val="tx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GB" sz="2400" dirty="0">
                <a:solidFill>
                  <a:schemeClr val="tx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Wingdings" pitchFamily="2" charset="2"/>
              </a:rPr>
              <a:t>)</a:t>
            </a:r>
            <a:br>
              <a:rPr lang="en-GB" sz="24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2400" b="1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outine non-standardized assessment:</a:t>
            </a:r>
            <a:br>
              <a:rPr lang="en-GB" sz="24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24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24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Specificity 84.6–100%, Sensitivity 61–76.6%</a:t>
            </a:r>
            <a:endParaRPr lang="en-GB" sz="2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Bildobjekt 5" descr="En bild som visar text, skärmbild&#10;&#10;Automatiskt genererad beskrivning">
            <a:extLst>
              <a:ext uri="{FF2B5EF4-FFF2-40B4-BE49-F238E27FC236}">
                <a16:creationId xmlns:a16="http://schemas.microsoft.com/office/drawing/2014/main" id="{8674155A-DBAF-A827-426A-E87E5EDE742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51388" b="2278"/>
          <a:stretch/>
        </p:blipFill>
        <p:spPr>
          <a:xfrm>
            <a:off x="145996" y="1191102"/>
            <a:ext cx="7586325" cy="2879764"/>
          </a:xfrm>
          <a:prstGeom prst="roundRect">
            <a:avLst/>
          </a:prstGeom>
        </p:spPr>
      </p:pic>
    </p:spTree>
    <p:extLst>
      <p:ext uri="{BB962C8B-B14F-4D97-AF65-F5344CB8AC3E}">
        <p14:creationId xmlns:p14="http://schemas.microsoft.com/office/powerpoint/2010/main" val="32406465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 2013 – 2022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97E0A228-C590-4D20-B05F-A6BF04A05448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100</Words>
  <Application>Microsoft Macintosh PowerPoint</Application>
  <PresentationFormat>Bredbild</PresentationFormat>
  <Paragraphs>10</Paragraphs>
  <Slides>1</Slides>
  <Notes>1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-tema</vt:lpstr>
      <vt:lpstr>The CABI score for Cardiac Arrest Brain Ischemia improves functional outcome prediction after cardiac arres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Isabelle Arctaedius</dc:creator>
  <cp:lastModifiedBy>Isabelle Arctaedius</cp:lastModifiedBy>
  <cp:revision>6</cp:revision>
  <dcterms:created xsi:type="dcterms:W3CDTF">2025-06-05T11:59:52Z</dcterms:created>
  <dcterms:modified xsi:type="dcterms:W3CDTF">2025-07-21T17:45:58Z</dcterms:modified>
</cp:coreProperties>
</file>